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00"/>
    <p:restoredTop sz="96197"/>
  </p:normalViewPr>
  <p:slideViewPr>
    <p:cSldViewPr snapToGrid="0" snapToObjects="1">
      <p:cViewPr varScale="1">
        <p:scale>
          <a:sx n="93" d="100"/>
          <a:sy n="93" d="100"/>
        </p:scale>
        <p:origin x="8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496484"/>
            <a:ext cx="6606540" cy="318346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4802717"/>
            <a:ext cx="5829300" cy="220768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38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958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486834"/>
            <a:ext cx="1675924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486834"/>
            <a:ext cx="4930616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282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158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279653"/>
            <a:ext cx="6703695" cy="3803649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119286"/>
            <a:ext cx="6703695" cy="200024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144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801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486836"/>
            <a:ext cx="670369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241551"/>
            <a:ext cx="3288089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340100"/>
            <a:ext cx="328808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241551"/>
            <a:ext cx="3304282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340100"/>
            <a:ext cx="33042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223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9390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119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316569"/>
            <a:ext cx="3934778" cy="6498167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084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316569"/>
            <a:ext cx="3934778" cy="6498167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493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486836"/>
            <a:ext cx="670369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434167"/>
            <a:ext cx="670369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7C00C-B9FC-8744-B5B4-E6D73BE54506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8475136"/>
            <a:ext cx="26231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341511-E1A8-6246-B42C-A1412EE571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37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FA0D99EA-F490-6640-9A8F-0FF8E59459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928" y="227157"/>
            <a:ext cx="7078544" cy="48158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7B68302-D1A0-6940-AC2D-AF6DE0199FC9}"/>
              </a:ext>
            </a:extLst>
          </p:cNvPr>
          <p:cNvSpPr txBox="1"/>
          <p:nvPr/>
        </p:nvSpPr>
        <p:spPr>
          <a:xfrm>
            <a:off x="423193" y="4674776"/>
            <a:ext cx="692601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1</a:t>
            </a:r>
            <a:r>
              <a:rPr lang="en-US" sz="1100" dirty="0"/>
              <a:t>: Injection of DF-1 chick fibroblast cells transfected with RCAS plasmids encoding H3.3K27M, PDGF-B, and </a:t>
            </a:r>
            <a:r>
              <a:rPr lang="en-US" sz="1100" dirty="0" err="1"/>
              <a:t>Cre</a:t>
            </a:r>
            <a:r>
              <a:rPr lang="en-US" sz="1100" dirty="0"/>
              <a:t> into the brainstem gives rise to DIPG tumor. Tumor cells can be seen in the brainstem (A) and cerebellum (B). (2x magnification, scalebar = 1 mm) Higher magnification (10x) images of the tumor are also shown. (10x magnification, scalebar = 200 </a:t>
            </a:r>
            <a:r>
              <a:rPr lang="el-GR" sz="1100" dirty="0"/>
              <a:t>μ</a:t>
            </a:r>
            <a:r>
              <a:rPr lang="en-US" sz="1100" dirty="0"/>
              <a:t>m) </a:t>
            </a:r>
          </a:p>
        </p:txBody>
      </p:sp>
    </p:spTree>
    <p:extLst>
      <p:ext uri="{BB962C8B-B14F-4D97-AF65-F5344CB8AC3E}">
        <p14:creationId xmlns:p14="http://schemas.microsoft.com/office/powerpoint/2010/main" val="1920846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8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2-21T16:40:32Z</dcterms:created>
  <dcterms:modified xsi:type="dcterms:W3CDTF">2022-02-21T16:41:43Z</dcterms:modified>
</cp:coreProperties>
</file>